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 bookmarkIdSeed="3">
  <p:sldMasterIdLst>
    <p:sldMasterId id="2147483660" r:id="rId4"/>
  </p:sldMasterIdLst>
  <p:notesMasterIdLst>
    <p:notesMasterId r:id="rId7"/>
  </p:notesMasterIdLst>
  <p:sldIdLst>
    <p:sldId id="363" r:id="rId5"/>
    <p:sldId id="364" r:id="rId6"/>
  </p:sldIdLst>
  <p:sldSz cx="6858000" cy="12192000"/>
  <p:notesSz cx="6858000" cy="9144000"/>
  <p:defaultTextStyle>
    <a:defPPr>
      <a:defRPr lang="en-US"/>
    </a:defPPr>
    <a:lvl1pPr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B11740F-73A5-ED53-03FA-7C3C734A29C8}" name="Bettina Rankl" initials="BR" userId="S::bettina.rankl@helmholtz-munich.de::97380fab-8b1e-4229-8ca2-3f0d225a3bbb" providerId="AD"/>
  <p188:author id="{987015A4-4641-43B9-7513-23A6909A08F7}" name="Guilherme Dragunas" initials="GD" userId="S::Guilherme.Dragunas@helmholtz-munich.de::04ad8124-b948-468a-8132-c0cd7b61b493" providerId="AD"/>
  <p188:author id="{A2ADA8BC-FF21-1DC9-D305-BC01F27B8134}" name="Ulku Rabia Korkmaz" initials="URK" userId="S::ulku-rabia.korkmaz@helmholtz-munich.de::4d499084-886a-4a8b-bf63-b1606a101008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abia ulku korkmaz" initials="" lastIdx="4" clrIdx="0"/>
  <p:cmAuthor id="2" name="Ulku Rabia Korkmaz" initials="" lastIdx="4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089" autoAdjust="0"/>
    <p:restoredTop sz="94582" autoAdjust="0"/>
  </p:normalViewPr>
  <p:slideViewPr>
    <p:cSldViewPr snapToGrid="0">
      <p:cViewPr>
        <p:scale>
          <a:sx n="100" d="100"/>
          <a:sy n="100" d="100"/>
        </p:scale>
        <p:origin x="1076" y="-4440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13" Type="http://schemas.microsoft.com/office/2018/10/relationships/authors" Target="author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94770353-C45D-B0AF-9292-E66045F60EB1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5CE2853-DB1D-071B-1FB4-A03C2C6FEDD2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55B9E92E-9378-44D2-B720-73FD5AE68CAF}" type="datetimeFigureOut">
              <a:rPr lang="LID4096"/>
              <a:pPr>
                <a:defRPr/>
              </a:pPr>
              <a:t>08/16/2025</a:t>
            </a:fld>
            <a:endParaRPr lang="en-DE"/>
          </a:p>
        </p:txBody>
      </p:sp>
      <p:sp>
        <p:nvSpPr>
          <p:cNvPr id="4" name="Slide Image Placeholder 3">
            <a:extLst>
              <a:ext uri="{FF2B5EF4-FFF2-40B4-BE49-F238E27FC236}">
                <a16:creationId xmlns:a16="http://schemas.microsoft.com/office/drawing/2014/main" id="{6E1C0341-7ACB-A10D-DBCF-3F2BEDEFDE40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DE" noProof="0"/>
          </a:p>
        </p:txBody>
      </p:sp>
      <p:sp>
        <p:nvSpPr>
          <p:cNvPr id="5" name="Notes Placeholder 4">
            <a:extLst>
              <a:ext uri="{FF2B5EF4-FFF2-40B4-BE49-F238E27FC236}">
                <a16:creationId xmlns:a16="http://schemas.microsoft.com/office/drawing/2014/main" id="{9E1D2C94-F654-7247-567D-CAA40540736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noProof="0"/>
              <a:t>Click to edit Master text styles</a:t>
            </a:r>
          </a:p>
          <a:p>
            <a:pPr lvl="1"/>
            <a:r>
              <a:rPr lang="en-GB" noProof="0"/>
              <a:t>Second level</a:t>
            </a:r>
          </a:p>
          <a:p>
            <a:pPr lvl="2"/>
            <a:r>
              <a:rPr lang="en-GB" noProof="0"/>
              <a:t>Third level</a:t>
            </a:r>
          </a:p>
          <a:p>
            <a:pPr lvl="3"/>
            <a:r>
              <a:rPr lang="en-GB" noProof="0"/>
              <a:t>Fourth level</a:t>
            </a:r>
          </a:p>
          <a:p>
            <a:pPr lvl="4"/>
            <a:r>
              <a:rPr lang="en-GB" noProof="0"/>
              <a:t>Fifth level</a:t>
            </a:r>
            <a:endParaRPr lang="en-DE" noProof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73CACCC-D189-C631-D41B-639079DCD2BF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361900-2F0E-F892-7086-CE5023F9DEB5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C259F1FD-3DC4-4AC5-AA2E-AC52D83FE3D4}" type="slidenum">
              <a:rPr lang="en-DE"/>
              <a:pPr>
                <a:defRPr/>
              </a:pPr>
              <a:t>‹#›</a:t>
            </a:fld>
            <a:endParaRPr lang="en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B13ED2-A251-0EE3-5190-1DF3C1EB1E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20A1D6-33A1-458F-BEB4-91F5485E401F}" type="datetimeFigureOut">
              <a:rPr lang="en-US"/>
              <a:pPr>
                <a:defRPr/>
              </a:pPr>
              <a:t>8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E85904-1298-720C-CF90-5AE8D98F78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AA3C0C-E9D7-CB6A-5CD9-49CB3AF8A3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07568C0-FC64-4A34-B522-F8153AB8DB9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1383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ECBCBD-2982-D3F3-D04A-435EF16F99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D034FA-6794-4244-B79C-22242C97C54B}" type="datetimeFigureOut">
              <a:rPr lang="en-US"/>
              <a:pPr>
                <a:defRPr/>
              </a:pPr>
              <a:t>8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0E1DBD-D481-A009-EAB6-8484E31274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E7050C-9DBC-E81F-3523-8A2138CBCB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B4B8ECA-D143-4245-8FB5-A4C5B860152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91063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13BEAA-C86B-DEC9-C3BB-2C9A315297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8C8328-9409-4E6C-AC09-34F09793ED6D}" type="datetimeFigureOut">
              <a:rPr lang="en-US"/>
              <a:pPr>
                <a:defRPr/>
              </a:pPr>
              <a:t>8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25AA4C-B500-CDB7-B3CD-DCE5F4D9FA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DDD02A-0564-B3CE-04AB-BE007892FF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E7F00E4-5DD5-4A2C-A681-D2BEB9EB797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25869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930EB4-C14D-4266-3F5C-5447CDE88C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4E51349-C9B7-4F98-9A49-06071F9825E0}" type="datetimeFigureOut">
              <a:rPr lang="en-US"/>
              <a:pPr>
                <a:defRPr/>
              </a:pPr>
              <a:t>8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31C0A7-B790-694F-C77B-8344CD0132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0B324A-82F5-D558-B412-43D72C0E71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873D3B-1586-4ED5-A4CA-3DB710E9D94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06998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E6BA2B-5BA8-0C62-1966-A073CC9138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81EFD9-0FF5-4E4B-92AB-D04B6E534076}" type="datetimeFigureOut">
              <a:rPr lang="en-US"/>
              <a:pPr>
                <a:defRPr/>
              </a:pPr>
              <a:t>8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9D8796-F7E6-2775-D38E-AD41BDE20F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FA8936-011D-DE3E-F448-B606CAF89E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ED3DFB-566F-4F8F-A585-0A792E46A3D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71937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F389B2F8-FF36-465D-EB9C-2656B1CDB4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E51CBA-E149-45D7-B041-481CCF1FAB31}" type="datetimeFigureOut">
              <a:rPr lang="en-US"/>
              <a:pPr>
                <a:defRPr/>
              </a:pPr>
              <a:t>8/16/2025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A4FD59CB-1674-D755-8114-C2732506EB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D145304C-FBF6-3EAE-A1B1-7C6D23F4AE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A9A715B-A403-4025-98F3-77E5C2C03C0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94497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10AFDFE0-431F-676B-0BE4-4B36E93DE0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7FA4382-E2A2-4700-9787-7753E81E52D2}" type="datetimeFigureOut">
              <a:rPr lang="en-US"/>
              <a:pPr>
                <a:defRPr/>
              </a:pPr>
              <a:t>8/16/2025</a:t>
            </a:fld>
            <a:endParaRPr 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1B6702BE-2FDF-F206-F45D-27A898EC13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C9B1BA55-A075-4736-8CD9-B740B97320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F6BB25F-3526-4EA8-8EB4-48D0DC8548F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2575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C9EB884E-851A-56D3-62B6-310F077AD7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FE3496-8795-43C3-AF60-E3C2277C1979}" type="datetimeFigureOut">
              <a:rPr lang="en-US"/>
              <a:pPr>
                <a:defRPr/>
              </a:pPr>
              <a:t>8/16/2025</a:t>
            </a:fld>
            <a:endParaRPr 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4F5C397D-A758-6011-B602-904347FC3E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283A80E4-F4AD-8E89-9CD8-9AB39D94A9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AE8E1D-929C-40D2-9E4D-376A54404E8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04059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F7443312-A38D-1792-3D0A-93C7B8C0CC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F5431BE-4ACD-4486-8139-31ACA31B697C}" type="datetimeFigureOut">
              <a:rPr lang="en-US"/>
              <a:pPr>
                <a:defRPr/>
              </a:pPr>
              <a:t>8/16/2025</a:t>
            </a:fld>
            <a:endParaRPr 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51A678BE-4A07-227A-F273-59D5BD9F1F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71FE1E3B-5201-4F98-B3E2-4785E37D9F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CA029A-DF54-43C6-BC1A-C45209AFC03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9629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64807F2D-16A1-21F6-C994-F47880EFBA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7616EB-9585-4735-ADAD-6679DC0D1F2B}" type="datetimeFigureOut">
              <a:rPr lang="en-US"/>
              <a:pPr>
                <a:defRPr/>
              </a:pPr>
              <a:t>8/16/2025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20FA0889-4BD2-C770-4D48-F6F6F905EA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9E210346-E1BA-2529-8DD6-DC6CFF5CE2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32F71D-BD76-4208-81C1-E14A70C9809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06521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089576E9-15D0-0ADE-A2B3-5DD9139FD1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30C2A96-2C23-4DC9-A844-2651D598CB6E}" type="datetimeFigureOut">
              <a:rPr lang="en-US"/>
              <a:pPr>
                <a:defRPr/>
              </a:pPr>
              <a:t>8/16/2025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2AA2789B-71A9-CD60-AE0D-AC59598D55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94AEA439-2A49-B09F-57C8-F71FD1B3C1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61783C9-6642-452C-B000-3E0DA3D517E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76416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51A342BC-2EE2-7B6F-482F-838CBF70860E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471488" y="649288"/>
            <a:ext cx="5915025" cy="2355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de-DE"/>
              <a:t>Click to edit Master title style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DE3E14DE-B206-035C-8A20-1989464DBBB4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471488" y="3244850"/>
            <a:ext cx="5915025" cy="7735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de-DE"/>
              <a:t>Click to edit Master text styles</a:t>
            </a:r>
          </a:p>
          <a:p>
            <a:pPr lvl="1"/>
            <a:r>
              <a:rPr lang="en-US" altLang="de-DE"/>
              <a:t>Second level</a:t>
            </a:r>
          </a:p>
          <a:p>
            <a:pPr lvl="2"/>
            <a:r>
              <a:rPr lang="en-US" altLang="de-DE"/>
              <a:t>Third level</a:t>
            </a:r>
          </a:p>
          <a:p>
            <a:pPr lvl="3"/>
            <a:r>
              <a:rPr lang="en-US" altLang="de-DE"/>
              <a:t>Fourth level</a:t>
            </a:r>
          </a:p>
          <a:p>
            <a:pPr lvl="4"/>
            <a:r>
              <a:rPr lang="en-US" altLang="de-DE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525591-6616-C4F7-C499-0D0A13C4BA1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11299825"/>
            <a:ext cx="1543050" cy="64928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F2E47081-8F7A-4C9F-9D9D-FD116561B901}" type="datetimeFigureOut">
              <a:rPr lang="en-US"/>
              <a:pPr>
                <a:defRPr/>
              </a:pPr>
              <a:t>8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88A516-3127-C877-09B8-749A7FD8EB3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11299825"/>
            <a:ext cx="2314575" cy="64928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6AE7D4-E2E0-4FCE-1687-45BD59DB789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11299825"/>
            <a:ext cx="1543050" cy="64928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502C790F-3B47-4FB2-8B5A-12AA69C1EC3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2pPr>
      <a:lvl3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3pPr>
      <a:lvl4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4pPr>
      <a:lvl5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5pPr>
      <a:lvl6pPr marL="4572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6pPr>
      <a:lvl7pPr marL="9144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7pPr>
      <a:lvl8pPr marL="13716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8pPr>
      <a:lvl9pPr marL="18288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171450" indent="-171450" algn="l" defTabSz="685800" rtl="0" eaLnBrk="0" fontAlgn="base" hangingPunct="0">
        <a:lnSpc>
          <a:spcPct val="90000"/>
        </a:lnSpc>
        <a:spcBef>
          <a:spcPts val="750"/>
        </a:spcBef>
        <a:spcAft>
          <a:spcPct val="0"/>
        </a:spcAft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>
            <a:extLst>
              <a:ext uri="{FF2B5EF4-FFF2-40B4-BE49-F238E27FC236}">
                <a16:creationId xmlns:a16="http://schemas.microsoft.com/office/drawing/2014/main" id="{254DC5A1-270A-D07C-8CF5-50400E71819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330200" y="364067"/>
            <a:ext cx="6146799" cy="8983134"/>
          </a:xfrm>
        </p:spPr>
        <p:txBody>
          <a:bodyPr/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 S1.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DE were tested for corticosteroids like dexamethasone, betamethasone, </a:t>
            </a:r>
            <a:r>
              <a:rPr lang="en-US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lumethasone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prednisolone, 6-alpho-mehylprednisolo and </a:t>
            </a:r>
            <a:r>
              <a:rPr lang="en-US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riamcinolomacetonid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A LC-MS/MS method to detect these substances in meat, water and protein rich matrices was used. The method is validated and is in line with EU commission decision 2002/657/EG. </a:t>
            </a:r>
            <a:r>
              <a:rPr lang="de-D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* = Limit </a:t>
            </a:r>
            <a:r>
              <a:rPr lang="de-D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quantitation</a:t>
            </a:r>
            <a:r>
              <a:rPr lang="de-DE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 S2.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linical phenotypes of the patients who donated PBMCs.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bbreviations: </a:t>
            </a:r>
            <a:r>
              <a:rPr lang="en-US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.i.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per inhalation) , </a:t>
            </a:r>
            <a:r>
              <a:rPr lang="en-US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.o.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Per </a:t>
            </a:r>
            <a:r>
              <a:rPr lang="en-US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s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or s-c- subcutaneous .</a:t>
            </a:r>
            <a:endParaRPr lang="de-DE" sz="11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6252425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1">
            <a:extLst>
              <a:ext uri="{FF2B5EF4-FFF2-40B4-BE49-F238E27FC236}">
                <a16:creationId xmlns:a16="http://schemas.microsoft.com/office/drawing/2014/main" id="{B47A5EA9-13E3-6A51-D953-9A83805150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7400" y="5710238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de-DE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421C73C3-4060-377E-6FC3-3784BA841A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4736" y="812272"/>
            <a:ext cx="5748528" cy="3144012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DC0BE673-57A2-E559-C8AF-2EEEF86DCF7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0" y="98325"/>
            <a:ext cx="190817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de-DE" altLang="en-US" b="1" dirty="0"/>
              <a:t>Table S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BB87CFE-CB59-6963-6191-54E0EFC90479}"/>
              </a:ext>
            </a:extLst>
          </p:cNvPr>
          <p:cNvSpPr txBox="1"/>
          <p:nvPr/>
        </p:nvSpPr>
        <p:spPr>
          <a:xfrm>
            <a:off x="310160" y="3956284"/>
            <a:ext cx="34544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b="1" dirty="0"/>
              <a:t>Table S2</a:t>
            </a:r>
          </a:p>
        </p:txBody>
      </p:sp>
      <p:graphicFrame>
        <p:nvGraphicFramePr>
          <p:cNvPr id="15" name="Table 14">
            <a:extLst>
              <a:ext uri="{FF2B5EF4-FFF2-40B4-BE49-F238E27FC236}">
                <a16:creationId xmlns:a16="http://schemas.microsoft.com/office/drawing/2014/main" id="{AAA511E6-76C5-3EE7-EC9F-BEAB67C1AC8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38446602"/>
              </p:ext>
            </p:extLst>
          </p:nvPr>
        </p:nvGraphicFramePr>
        <p:xfrm>
          <a:off x="554735" y="4584700"/>
          <a:ext cx="5407914" cy="4962759"/>
        </p:xfrm>
        <a:graphic>
          <a:graphicData uri="http://schemas.openxmlformats.org/drawingml/2006/table">
            <a:tbl>
              <a:tblPr firstRow="1" firstCol="1" bandRow="1"/>
              <a:tblGrid>
                <a:gridCol w="642319">
                  <a:extLst>
                    <a:ext uri="{9D8B030D-6E8A-4147-A177-3AD203B41FA5}">
                      <a16:colId xmlns:a16="http://schemas.microsoft.com/office/drawing/2014/main" val="3767826521"/>
                    </a:ext>
                  </a:extLst>
                </a:gridCol>
                <a:gridCol w="953119">
                  <a:extLst>
                    <a:ext uri="{9D8B030D-6E8A-4147-A177-3AD203B41FA5}">
                      <a16:colId xmlns:a16="http://schemas.microsoft.com/office/drawing/2014/main" val="3379776541"/>
                    </a:ext>
                  </a:extLst>
                </a:gridCol>
                <a:gridCol w="953119">
                  <a:extLst>
                    <a:ext uri="{9D8B030D-6E8A-4147-A177-3AD203B41FA5}">
                      <a16:colId xmlns:a16="http://schemas.microsoft.com/office/drawing/2014/main" val="1639532808"/>
                    </a:ext>
                  </a:extLst>
                </a:gridCol>
                <a:gridCol w="953119">
                  <a:extLst>
                    <a:ext uri="{9D8B030D-6E8A-4147-A177-3AD203B41FA5}">
                      <a16:colId xmlns:a16="http://schemas.microsoft.com/office/drawing/2014/main" val="4079740712"/>
                    </a:ext>
                  </a:extLst>
                </a:gridCol>
                <a:gridCol w="953119">
                  <a:extLst>
                    <a:ext uri="{9D8B030D-6E8A-4147-A177-3AD203B41FA5}">
                      <a16:colId xmlns:a16="http://schemas.microsoft.com/office/drawing/2014/main" val="944563459"/>
                    </a:ext>
                  </a:extLst>
                </a:gridCol>
                <a:gridCol w="953119">
                  <a:extLst>
                    <a:ext uri="{9D8B030D-6E8A-4147-A177-3AD203B41FA5}">
                      <a16:colId xmlns:a16="http://schemas.microsoft.com/office/drawing/2014/main" val="4179839809"/>
                    </a:ext>
                  </a:extLst>
                </a:gridCol>
              </a:tblGrid>
              <a:tr h="135995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2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x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2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2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moker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2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dication (Substance + Route)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2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llergens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2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iagnosis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32298179"/>
                  </a:ext>
                </a:extLst>
              </a:tr>
              <a:tr h="98663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2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de-D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2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6 - 35</a:t>
                      </a:r>
                      <a:endParaRPr lang="de-D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n </a:t>
                      </a:r>
                      <a:r>
                        <a:rPr lang="de-DE" sz="12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moker</a:t>
                      </a:r>
                      <a:endParaRPr lang="de-D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eclometasone  p.i.,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ormoterol  p.i.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et hair, house dust mites, pollen, dust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sthma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21806578"/>
                  </a:ext>
                </a:extLst>
              </a:tr>
              <a:tr h="109277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2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de-D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6 - 55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n </a:t>
                      </a:r>
                      <a:r>
                        <a:rPr lang="de-DE" sz="11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moker</a:t>
                      </a:r>
                      <a:endParaRPr lang="de-DE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de-D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exofenadine p.o., Levocetirizine p.o.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ay fever, hazelnuts, codeine, nickel, cobalt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sthma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881379"/>
                  </a:ext>
                </a:extLst>
              </a:tr>
              <a:tr h="65133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8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n </a:t>
                      </a:r>
                      <a:r>
                        <a:rPr lang="de-DE" sz="11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moker</a:t>
                      </a:r>
                      <a:endParaRPr lang="de-DE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de-D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bastine p.o.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ouse dust mites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llergic Asthma, Eosinophil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79743029"/>
                  </a:ext>
                </a:extLst>
              </a:tr>
              <a:tr h="87205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5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n </a:t>
                      </a:r>
                      <a:r>
                        <a:rPr lang="de-DE" sz="11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moker</a:t>
                      </a:r>
                      <a:endParaRPr lang="de-DE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2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bastine p.o., Dupilumab s.c.</a:t>
                      </a:r>
                      <a:endParaRPr lang="de-D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200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llergic</a:t>
                      </a:r>
                      <a:r>
                        <a:rPr lang="de-DE" sz="12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Asthma</a:t>
                      </a:r>
                      <a:endParaRPr lang="de-D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66926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625403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2D4EC1050202074A85E3168018FE7E3C" ma:contentTypeVersion="16" ma:contentTypeDescription="Ein neues Dokument erstellen." ma:contentTypeScope="" ma:versionID="fd46b7f508b16e3f2670147541b47e0a">
  <xsd:schema xmlns:xsd="http://www.w3.org/2001/XMLSchema" xmlns:xs="http://www.w3.org/2001/XMLSchema" xmlns:p="http://schemas.microsoft.com/office/2006/metadata/properties" xmlns:ns3="c4ec3b07-69a8-4e6d-a131-23b97a3a571d" xmlns:ns4="1403a253-097b-46e0-8e00-e45627f0c628" targetNamespace="http://schemas.microsoft.com/office/2006/metadata/properties" ma:root="true" ma:fieldsID="e36dc8c04346a1e95dd31ea03019dbb4" ns3:_="" ns4:_="">
    <xsd:import namespace="c4ec3b07-69a8-4e6d-a131-23b97a3a571d"/>
    <xsd:import namespace="1403a253-097b-46e0-8e00-e45627f0c628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_activity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DateTaken" minOccurs="0"/>
                <xsd:element ref="ns3:MediaServiceLocation" minOccurs="0"/>
                <xsd:element ref="ns3:MediaServiceOCR" minOccurs="0"/>
                <xsd:element ref="ns3:MediaServiceObjectDetectorVersions" minOccurs="0"/>
                <xsd:element ref="ns3:MediaLengthInSeconds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4ec3b07-69a8-4e6d-a131-23b97a3a571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_activity" ma:index="10" nillable="true" ma:displayName="_activity" ma:hidden="true" ma:internalName="_activity">
      <xsd:simpleType>
        <xsd:restriction base="dms:Note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7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Location" ma:index="18" nillable="true" ma:displayName="Location" ma:indexed="true" ma:internalName="MediaServiceLocation" ma:readOnly="true">
      <xsd:simpleType>
        <xsd:restriction base="dms:Text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ObjectDetectorVersions" ma:index="2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MediaServiceSystemTags" ma:index="22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3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403a253-097b-46e0-8e00-e45627f0c628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Freigegeben für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Freigegeben für -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Freigabehinweis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haltstyp"/>
        <xsd:element ref="dc:title" minOccurs="0" maxOccurs="1" ma:index="4" ma:displayName="Ti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c4ec3b07-69a8-4e6d-a131-23b97a3a571d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690FF1A5-9D6A-4851-A989-B5A8B3A7158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4ec3b07-69a8-4e6d-a131-23b97a3a571d"/>
    <ds:schemaRef ds:uri="1403a253-097b-46e0-8e00-e45627f0c62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E0E505E3-71A2-4AAE-8B9F-477128CDB500}">
  <ds:schemaRefs>
    <ds:schemaRef ds:uri="http://purl.org/dc/elements/1.1/"/>
    <ds:schemaRef ds:uri="http://schemas.microsoft.com/office/2006/documentManagement/types"/>
    <ds:schemaRef ds:uri="http://www.w3.org/XML/1998/namespace"/>
    <ds:schemaRef ds:uri="http://schemas.microsoft.com/office/2006/metadata/properties"/>
    <ds:schemaRef ds:uri="c4ec3b07-69a8-4e6d-a131-23b97a3a571d"/>
    <ds:schemaRef ds:uri="http://purl.org/dc/terms/"/>
    <ds:schemaRef ds:uri="http://purl.org/dc/dcmitype/"/>
    <ds:schemaRef ds:uri="1403a253-097b-46e0-8e00-e45627f0c628"/>
    <ds:schemaRef ds:uri="http://schemas.microsoft.com/office/infopath/2007/PartnerControls"/>
    <ds:schemaRef ds:uri="http://schemas.openxmlformats.org/package/2006/metadata/core-properties"/>
  </ds:schemaRefs>
</ds:datastoreItem>
</file>

<file path=customXml/itemProps3.xml><?xml version="1.0" encoding="utf-8"?>
<ds:datastoreItem xmlns:ds="http://schemas.openxmlformats.org/officeDocument/2006/customXml" ds:itemID="{A000D908-BC7E-485B-864C-9FD08EA48795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99</Words>
  <Application>Microsoft Office PowerPoint</Application>
  <PresentationFormat>Widescreen</PresentationFormat>
  <Paragraphs>3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>FH OOE Management Gmb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osifov Miroslav</dc:creator>
  <cp:lastModifiedBy>Ulku Rabia Korkmaz</cp:lastModifiedBy>
  <cp:revision>274</cp:revision>
  <dcterms:created xsi:type="dcterms:W3CDTF">2022-12-23T18:00:32Z</dcterms:created>
  <dcterms:modified xsi:type="dcterms:W3CDTF">2025-08-16T16:45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D4EC1050202074A85E3168018FE7E3C</vt:lpwstr>
  </property>
  <property fmtid="{D5CDD505-2E9C-101B-9397-08002B2CF9AE}" pid="3" name="_activity">
    <vt:lpwstr/>
  </property>
</Properties>
</file>